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4"/>
  </p:notesMasterIdLst>
  <p:sldIdLst>
    <p:sldId id="301" r:id="rId2"/>
    <p:sldId id="300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98" autoAdjust="0"/>
    <p:restoredTop sz="93402" autoAdjust="0"/>
  </p:normalViewPr>
  <p:slideViewPr>
    <p:cSldViewPr snapToGrid="0" snapToObjects="1">
      <p:cViewPr varScale="1">
        <p:scale>
          <a:sx n="90" d="100"/>
          <a:sy n="90" d="100"/>
        </p:scale>
        <p:origin x="3744" y="6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A0D68D-F477-C84C-8F29-F8B8BD126D48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5915D-9B53-0F41-BA0E-57D3245DD84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840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954CF-0850-074B-B1B4-77C83287CE5C}" type="datetimeFigureOut">
              <a:rPr kumimoji="1" lang="ja-JP" altLang="en-US" smtClean="0"/>
              <a:pPr/>
              <a:t>2021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624F0-97A2-4942-8EDC-9C6E822A236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939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DD515B4-5EBA-4647-9BCC-4E85F93C5A50}"/>
              </a:ext>
            </a:extLst>
          </p:cNvPr>
          <p:cNvSpPr txBox="1"/>
          <p:nvPr/>
        </p:nvSpPr>
        <p:spPr>
          <a:xfrm>
            <a:off x="779329" y="983637"/>
            <a:ext cx="52993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mproving quantitative traits in self-pollinated crops using simulation-based selection with minimal crossing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0901388-CFB1-7141-9084-5199E2382997}"/>
              </a:ext>
            </a:extLst>
          </p:cNvPr>
          <p:cNvSpPr txBox="1"/>
          <p:nvPr/>
        </p:nvSpPr>
        <p:spPr>
          <a:xfrm>
            <a:off x="779329" y="2174424"/>
            <a:ext cx="50945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isuke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ekin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Mai Tsuda, Shiori Yabe, Takehiko Shimizu, Kayo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achit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Masayasu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Saruta, Tetsuya Yamada, Masao Ishimoto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Hiroyoshi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Iwata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kito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aga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71526A0-516C-794A-AC31-C826C815831E}"/>
              </a:ext>
            </a:extLst>
          </p:cNvPr>
          <p:cNvSpPr txBox="1"/>
          <p:nvPr/>
        </p:nvSpPr>
        <p:spPr>
          <a:xfrm>
            <a:off x="779329" y="3272878"/>
            <a:ext cx="36221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ne supplemental figure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1477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E8FE4BB9-3EFC-764B-82A7-5813DE036573}"/>
              </a:ext>
            </a:extLst>
          </p:cNvPr>
          <p:cNvSpPr/>
          <p:nvPr/>
        </p:nvSpPr>
        <p:spPr>
          <a:xfrm>
            <a:off x="603800" y="8901279"/>
            <a:ext cx="5512435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. Accuracy of the prediction model to the variation of RILs in the following years.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nd (b) indicate the relationship between predicted values calculated using the NICS3-2013 model and protein content observed in 2014 and 2015, respectively.</a:t>
            </a:r>
            <a:endParaRPr lang="ja-JP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ja-JP" sz="1000" dirty="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0BB991B-2CBA-4B43-94BA-B811BCC2ED91}"/>
              </a:ext>
            </a:extLst>
          </p:cNvPr>
          <p:cNvGrpSpPr/>
          <p:nvPr/>
        </p:nvGrpSpPr>
        <p:grpSpPr>
          <a:xfrm>
            <a:off x="627491" y="1339441"/>
            <a:ext cx="4908169" cy="7450769"/>
            <a:chOff x="627491" y="592224"/>
            <a:chExt cx="4908169" cy="7450769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9B43BF26-0F5B-7946-8331-53DF2F0029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84376" y="592224"/>
              <a:ext cx="4351284" cy="3175558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FB162EEB-8BEF-9B43-9E02-CA7A051F49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84376" y="4495970"/>
              <a:ext cx="4351284" cy="3175558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2CC5F1B-BAEE-504E-BE65-3FF542D691AD}"/>
                </a:ext>
              </a:extLst>
            </p:cNvPr>
            <p:cNvSpPr txBox="1"/>
            <p:nvPr/>
          </p:nvSpPr>
          <p:spPr>
            <a:xfrm rot="16200000">
              <a:off x="19325" y="2178506"/>
              <a:ext cx="17027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rotein content (2014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E0DDE19-9A2F-D244-BB85-291D80809BF2}"/>
                </a:ext>
              </a:extLst>
            </p:cNvPr>
            <p:cNvSpPr txBox="1"/>
            <p:nvPr/>
          </p:nvSpPr>
          <p:spPr>
            <a:xfrm rot="16200000">
              <a:off x="19325" y="6019251"/>
              <a:ext cx="17027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rotein content (2015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52F62D8-5B65-AB47-8206-C2F541185C24}"/>
                </a:ext>
              </a:extLst>
            </p:cNvPr>
            <p:cNvSpPr txBox="1"/>
            <p:nvPr/>
          </p:nvSpPr>
          <p:spPr>
            <a:xfrm>
              <a:off x="1979555" y="3853039"/>
              <a:ext cx="27238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redicted value (NICS3_2013 model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6A5871C-BCE0-834B-8B37-77F573DB64F4}"/>
                </a:ext>
              </a:extLst>
            </p:cNvPr>
            <p:cNvSpPr txBox="1"/>
            <p:nvPr/>
          </p:nvSpPr>
          <p:spPr>
            <a:xfrm>
              <a:off x="1979555" y="7765994"/>
              <a:ext cx="27238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redicted value (NICS3_2013 model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81588815-D64B-2D4B-897B-FE5B116039C9}"/>
                </a:ext>
              </a:extLst>
            </p:cNvPr>
            <p:cNvSpPr txBox="1"/>
            <p:nvPr/>
          </p:nvSpPr>
          <p:spPr>
            <a:xfrm>
              <a:off x="3957863" y="1100358"/>
              <a:ext cx="8883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r 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.67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C86433E7-82A5-A345-AC67-6A33BD4F02D2}"/>
                </a:ext>
              </a:extLst>
            </p:cNvPr>
            <p:cNvSpPr txBox="1"/>
            <p:nvPr/>
          </p:nvSpPr>
          <p:spPr>
            <a:xfrm>
              <a:off x="3957862" y="4885912"/>
              <a:ext cx="8883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r 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0.62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1F4B17D-FF81-0846-88C6-2A2D6E9B5125}"/>
                </a:ext>
              </a:extLst>
            </p:cNvPr>
            <p:cNvSpPr txBox="1"/>
            <p:nvPr/>
          </p:nvSpPr>
          <p:spPr>
            <a:xfrm>
              <a:off x="627491" y="614369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EBDC43D9-2479-2641-8176-298FD80B34C0}"/>
                </a:ext>
              </a:extLst>
            </p:cNvPr>
            <p:cNvSpPr txBox="1"/>
            <p:nvPr/>
          </p:nvSpPr>
          <p:spPr>
            <a:xfrm>
              <a:off x="627491" y="4219425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7128895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51</TotalTime>
  <Words>125</Words>
  <Application>Microsoft Office PowerPoint</Application>
  <PresentationFormat>A4 210 x 297 mm</PresentationFormat>
  <Paragraphs>1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Yu Gothic</vt:lpstr>
      <vt:lpstr>Arial</vt:lpstr>
      <vt:lpstr>Calibri</vt:lpstr>
      <vt:lpstr>Calibri Light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関根大輔</dc:creator>
  <cp:lastModifiedBy>加賀　秋人</cp:lastModifiedBy>
  <cp:revision>476</cp:revision>
  <dcterms:created xsi:type="dcterms:W3CDTF">2017-08-18T06:55:08Z</dcterms:created>
  <dcterms:modified xsi:type="dcterms:W3CDTF">2021-06-23T12:00:35Z</dcterms:modified>
</cp:coreProperties>
</file>